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08" r:id="rId2"/>
    <p:sldId id="368" r:id="rId3"/>
    <p:sldId id="387" r:id="rId4"/>
    <p:sldId id="395" r:id="rId5"/>
    <p:sldId id="396" r:id="rId6"/>
    <p:sldId id="397" r:id="rId7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16" userDrawn="1">
          <p15:clr>
            <a:srgbClr val="A4A3A4"/>
          </p15:clr>
        </p15:guide>
        <p15:guide id="2" pos="7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74AD9"/>
    <a:srgbClr val="6B1DD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50"/>
    <p:restoredTop sz="95156" autoAdjust="0"/>
  </p:normalViewPr>
  <p:slideViewPr>
    <p:cSldViewPr snapToGrid="0">
      <p:cViewPr varScale="1">
        <p:scale>
          <a:sx n="80" d="100"/>
          <a:sy n="80" d="100"/>
        </p:scale>
        <p:origin x="108" y="732"/>
      </p:cViewPr>
      <p:guideLst>
        <p:guide orient="horz" pos="816"/>
        <p:guide pos="72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4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ngde Wang" userId="79e0d998-234f-4701-982c-6b186ccbe4ae" providerId="ADAL" clId="{51A8DA1E-6E8A-4C30-BE6B-9DB06E375FDF}"/>
    <pc:docChg chg="custSel modSld">
      <pc:chgData name="Qingde Wang" userId="79e0d998-234f-4701-982c-6b186ccbe4ae" providerId="ADAL" clId="{51A8DA1E-6E8A-4C30-BE6B-9DB06E375FDF}" dt="2022-09-07T14:20:54.710" v="0" actId="478"/>
      <pc:docMkLst>
        <pc:docMk/>
      </pc:docMkLst>
      <pc:sldChg chg="delSp mod">
        <pc:chgData name="Qingde Wang" userId="79e0d998-234f-4701-982c-6b186ccbe4ae" providerId="ADAL" clId="{51A8DA1E-6E8A-4C30-BE6B-9DB06E375FDF}" dt="2022-09-07T14:20:54.710" v="0" actId="478"/>
        <pc:sldMkLst>
          <pc:docMk/>
          <pc:sldMk cId="3190892280" sldId="387"/>
        </pc:sldMkLst>
        <pc:spChg chg="del">
          <ac:chgData name="Qingde Wang" userId="79e0d998-234f-4701-982c-6b186ccbe4ae" providerId="ADAL" clId="{51A8DA1E-6E8A-4C30-BE6B-9DB06E375FDF}" dt="2022-09-07T14:20:54.710" v="0" actId="478"/>
          <ac:spMkLst>
            <pc:docMk/>
            <pc:sldMk cId="3190892280" sldId="387"/>
            <ac:spMk id="8" creationId="{0B332A41-46B5-452D-8AEA-E30028E0F0C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5A1010-FCD6-3D42-A254-D0CB09021CD9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8D7AF8-8C98-EC41-AF96-26B863A8A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3371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8D7AF8-8C98-EC41-AF96-26B863A8A4E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915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934607B-041E-41B3-8152-CB173474DC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C72AFDD2-ABEC-47F0-B8DD-1A5784BD0B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BFAA548-ABE3-4511-ADE7-7B33C174B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798D614-021B-45A6-95B4-3E95E6BEA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3ACB102-B0F2-4C1E-9B61-942FED191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009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C933CCD-705A-44B1-A87B-7F586C0D91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680F85D-4470-4861-8AFC-32D4A95DE1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2DA482A-CB4A-4D41-A20A-21319B6FF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90E6069-9E9C-4A25-AF6B-5906540A1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5FF8CB7-9921-4740-9C7C-625BD4632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969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E0ED4303-2536-4518-A204-3E99C38A63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EAC1933-290E-480E-82F6-02A41B9DAE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5BD9112-4164-4F65-9810-B6E8E8230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A84B237-BF32-49B0-B4C4-4CA06025F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5220559-F89F-4E6F-834A-5221ADB96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612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F74071C-743D-4F71-888E-FF5F111E1D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DEFA4A5-2150-4BCD-9771-B1E9ADE0D7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98FE4C0-8A8C-4B85-BFE0-F0DAAA949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9402315-885E-4668-B307-C1A18E7442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C74D0EC-9B06-44C7-ADE4-BF1FB1BB8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697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A065F89-61C6-45C6-848C-E28F6A66BC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9DAB917-2708-4160-87FF-1C243FE284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61982DC-87DB-4F47-9A82-1B761A876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C1FE048-DB36-4A8A-8A15-D2E12D15B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9619D80-5120-466A-B399-4AD24E7F5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295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22B0003-56E1-43A9-8148-359C98CBA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9F50DD6-7C28-4935-A6E4-A41A6E839C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18DDD22-B872-4BA5-9C41-16CC56D7B7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35F075A-5588-48E8-8B8E-74858DED6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C6150AD-99B9-4976-90DD-308531D04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61FBCAE-9A04-4CD1-AD16-4896B56D2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86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A8E38B1-F0C1-41B5-A0AA-06F569807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C0322C3-F8E8-4F1D-BE5B-94424D6B51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3FE149C-C5A3-48CA-80FF-13DD9D36E3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2C1531F-9D19-440D-A319-9195867D77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C262379D-719B-4747-9A4C-5FDBCCC88B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257571B7-FE6D-463B-977A-2CAFC9969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FCE8309A-1215-45DB-9586-C77DC6E12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D80EA7E0-4ED1-4F60-B2F2-C8F9488CB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191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95FBF48-D3FC-45AB-8DD8-068AE1279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D6BD7EC1-7782-4445-AF42-E961CA98E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4B7DCCD9-5EE2-4919-81D7-E6F751C86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D6975F03-692A-4F51-B0A9-56CFD28E7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731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6442F4E-2282-4C0D-8098-FA32601B2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79E6A0E8-9570-4D2A-920B-EDC2249A0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D9BAF862-A2A1-4244-B551-256FEAF02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135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19BB9BC-5494-4DEF-B889-A5A93AF39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207C2E6-D8E2-4BC7-890A-1E613B45BC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5B5F315-7E9D-46EA-BC19-0CD540C46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F4CBD8E-7877-448D-A7C1-FDCD58206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7DF2E5F-AED2-49F3-BFC3-A60DFAD09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CCCB51D-FFF8-4028-B07C-A56002290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832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52F4FA6-1E9F-4C7E-85FE-2FDE239ABD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0C223AC-B2E3-4017-8BB0-9A0218BD18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D9AAE5E-0801-4DE9-9C8C-DEBD2C85ED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3979506-D236-41E0-B8D8-0A642E336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B26BF19-71C6-4301-9CB3-DB902E8C2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12FC05C-20CF-4624-A2E4-4C66D0198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319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04BAFB88-BA59-48A4-BD88-33635C90E0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910C310-AD06-4BD9-BE11-67A4154013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E810C1C-708C-4581-A677-EB1AF87A90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8A471-33BE-4901-954C-EDCC4C904402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2E17F0D-AE1A-416A-A104-D26B0BEEB9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CD8E717-8247-4B1F-87AA-4B3356E7F6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B6E58-DB54-4061-924E-4B82D6D4C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712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4" Type="http://schemas.openxmlformats.org/officeDocument/2006/relationships/image" Target="../media/image2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1B1FAAC5-C85F-FE4D-AC09-5D6FF8630B04}"/>
              </a:ext>
            </a:extLst>
          </p:cNvPr>
          <p:cNvSpPr txBox="1"/>
          <p:nvPr/>
        </p:nvSpPr>
        <p:spPr>
          <a:xfrm>
            <a:off x="855587" y="1031279"/>
            <a:ext cx="16361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Figure S1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1F056F2F-2469-C14C-B614-482939DE6A3E}"/>
              </a:ext>
            </a:extLst>
          </p:cNvPr>
          <p:cNvSpPr txBox="1"/>
          <p:nvPr/>
        </p:nvSpPr>
        <p:spPr>
          <a:xfrm>
            <a:off x="2491741" y="1031279"/>
            <a:ext cx="398057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i="1" dirty="0"/>
              <a:t>Adar D1113H </a:t>
            </a:r>
            <a:r>
              <a:rPr lang="en-US" sz="2800" b="1" dirty="0"/>
              <a:t>Genotypin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AA34B07E-7ED0-4D9C-919E-84A36AADB0BB}"/>
              </a:ext>
            </a:extLst>
          </p:cNvPr>
          <p:cNvSpPr txBox="1"/>
          <p:nvPr/>
        </p:nvSpPr>
        <p:spPr>
          <a:xfrm>
            <a:off x="4226147" y="2325923"/>
            <a:ext cx="33164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/>
              <a:t>Wt</a:t>
            </a:r>
            <a:r>
              <a:rPr lang="en-US" sz="2400" b="1" dirty="0"/>
              <a:t>            Het          Homo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FB6C0866-7045-46DA-A668-F9C3DAC85D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1669" y="2787588"/>
            <a:ext cx="4642797" cy="151395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0EE76096-AC88-4047-8C65-CE22336B22B9}"/>
              </a:ext>
            </a:extLst>
          </p:cNvPr>
          <p:cNvSpPr txBox="1"/>
          <p:nvPr/>
        </p:nvSpPr>
        <p:spPr>
          <a:xfrm>
            <a:off x="3303109" y="2474758"/>
            <a:ext cx="5373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M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762290BF-E8F7-4F79-B9FA-3C1B7E16DAEA}"/>
              </a:ext>
            </a:extLst>
          </p:cNvPr>
          <p:cNvSpPr txBox="1"/>
          <p:nvPr/>
        </p:nvSpPr>
        <p:spPr>
          <a:xfrm>
            <a:off x="8021631" y="3424612"/>
            <a:ext cx="5373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WT</a:t>
            </a:r>
          </a:p>
        </p:txBody>
      </p:sp>
      <p:sp>
        <p:nvSpPr>
          <p:cNvPr id="10" name="Isosceles Triangle 28">
            <a:extLst>
              <a:ext uri="{FF2B5EF4-FFF2-40B4-BE49-F238E27FC236}">
                <a16:creationId xmlns:a16="http://schemas.microsoft.com/office/drawing/2014/main" xmlns="" id="{ADD92F42-E8D2-4B4B-96CB-C8D4CD110033}"/>
              </a:ext>
            </a:extLst>
          </p:cNvPr>
          <p:cNvSpPr/>
          <p:nvPr/>
        </p:nvSpPr>
        <p:spPr>
          <a:xfrm rot="16200000">
            <a:off x="7900529" y="3553915"/>
            <a:ext cx="70148" cy="102174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FB3F66C6-60F8-4CE0-8462-AA33546B7BC3}"/>
              </a:ext>
            </a:extLst>
          </p:cNvPr>
          <p:cNvSpPr txBox="1"/>
          <p:nvPr/>
        </p:nvSpPr>
        <p:spPr>
          <a:xfrm>
            <a:off x="8021631" y="3122265"/>
            <a:ext cx="164019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G to C mutant</a:t>
            </a:r>
          </a:p>
        </p:txBody>
      </p:sp>
      <p:sp>
        <p:nvSpPr>
          <p:cNvPr id="12" name="Isosceles Triangle 31">
            <a:extLst>
              <a:ext uri="{FF2B5EF4-FFF2-40B4-BE49-F238E27FC236}">
                <a16:creationId xmlns:a16="http://schemas.microsoft.com/office/drawing/2014/main" xmlns="" id="{17490D2E-A1EF-4289-8376-96DD012BAB2B}"/>
              </a:ext>
            </a:extLst>
          </p:cNvPr>
          <p:cNvSpPr/>
          <p:nvPr/>
        </p:nvSpPr>
        <p:spPr>
          <a:xfrm rot="16200000">
            <a:off x="7884487" y="3313330"/>
            <a:ext cx="70148" cy="102174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1170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0AF26B42-5204-444B-8A27-8F1BF3052EB0}"/>
              </a:ext>
            </a:extLst>
          </p:cNvPr>
          <p:cNvSpPr txBox="1"/>
          <p:nvPr/>
        </p:nvSpPr>
        <p:spPr>
          <a:xfrm>
            <a:off x="1514558" y="895391"/>
            <a:ext cx="101693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Western blot showing ADAR1 protein in </a:t>
            </a:r>
            <a:r>
              <a:rPr lang="en-US" sz="2800" b="1" i="1" dirty="0"/>
              <a:t>Adar D1113H </a:t>
            </a:r>
            <a:r>
              <a:rPr lang="en-US" sz="2800" b="1" dirty="0"/>
              <a:t>mouse brain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9FF37503-5FBD-4FEA-A407-497B214A89BE}"/>
              </a:ext>
            </a:extLst>
          </p:cNvPr>
          <p:cNvSpPr txBox="1"/>
          <p:nvPr/>
        </p:nvSpPr>
        <p:spPr>
          <a:xfrm>
            <a:off x="673521" y="274289"/>
            <a:ext cx="16361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/>
              <a:t>Figure S2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A9805B98-2C88-4BAA-8896-C1E6810700E3}"/>
              </a:ext>
            </a:extLst>
          </p:cNvPr>
          <p:cNvSpPr txBox="1"/>
          <p:nvPr/>
        </p:nvSpPr>
        <p:spPr>
          <a:xfrm>
            <a:off x="2530800" y="274289"/>
            <a:ext cx="51190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ADAR1 protein levels in the brain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20450462-B261-1444-A90C-A44E4F9B6C6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434"/>
          <a:stretch/>
        </p:blipFill>
        <p:spPr>
          <a:xfrm>
            <a:off x="2948991" y="5606359"/>
            <a:ext cx="4502984" cy="61017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12BE377C-F276-2047-963A-F688EA3BDABD}"/>
              </a:ext>
            </a:extLst>
          </p:cNvPr>
          <p:cNvSpPr txBox="1"/>
          <p:nvPr/>
        </p:nvSpPr>
        <p:spPr>
          <a:xfrm>
            <a:off x="7692807" y="3001146"/>
            <a:ext cx="7072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/>
              <a:t>P110</a:t>
            </a:r>
          </a:p>
        </p:txBody>
      </p:sp>
      <p:sp>
        <p:nvSpPr>
          <p:cNvPr id="19" name="Isosceles Triangle 28">
            <a:extLst>
              <a:ext uri="{FF2B5EF4-FFF2-40B4-BE49-F238E27FC236}">
                <a16:creationId xmlns:a16="http://schemas.microsoft.com/office/drawing/2014/main" xmlns="" id="{CDA17A0D-3034-584A-98E7-5755B11F2E98}"/>
              </a:ext>
            </a:extLst>
          </p:cNvPr>
          <p:cNvSpPr/>
          <p:nvPr/>
        </p:nvSpPr>
        <p:spPr>
          <a:xfrm rot="16200000">
            <a:off x="7571705" y="3176169"/>
            <a:ext cx="70148" cy="102174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11E55FC-237B-E046-949D-EEE6638221F1}"/>
              </a:ext>
            </a:extLst>
          </p:cNvPr>
          <p:cNvSpPr txBox="1"/>
          <p:nvPr/>
        </p:nvSpPr>
        <p:spPr>
          <a:xfrm>
            <a:off x="7692807" y="2730883"/>
            <a:ext cx="7072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P150</a:t>
            </a:r>
          </a:p>
        </p:txBody>
      </p:sp>
      <p:sp>
        <p:nvSpPr>
          <p:cNvPr id="21" name="Isosceles Triangle 31">
            <a:extLst>
              <a:ext uri="{FF2B5EF4-FFF2-40B4-BE49-F238E27FC236}">
                <a16:creationId xmlns:a16="http://schemas.microsoft.com/office/drawing/2014/main" xmlns="" id="{0FCB09DB-BA73-5949-8D40-6B8F055B1FD0}"/>
              </a:ext>
            </a:extLst>
          </p:cNvPr>
          <p:cNvSpPr/>
          <p:nvPr/>
        </p:nvSpPr>
        <p:spPr>
          <a:xfrm rot="16200000">
            <a:off x="7555663" y="2921948"/>
            <a:ext cx="70148" cy="102174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 Box 2">
            <a:extLst>
              <a:ext uri="{FF2B5EF4-FFF2-40B4-BE49-F238E27FC236}">
                <a16:creationId xmlns:a16="http://schemas.microsoft.com/office/drawing/2014/main" xmlns="" id="{C0F6037F-F770-4743-9165-75F1E10865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30841" y="5688368"/>
            <a:ext cx="1000376" cy="40011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β</a:t>
            </a:r>
            <a:r>
              <a:rPr lang="en-US" sz="2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-actin</a:t>
            </a:r>
          </a:p>
        </p:txBody>
      </p:sp>
      <p:sp>
        <p:nvSpPr>
          <p:cNvPr id="23" name="Isosceles Triangle 31">
            <a:extLst>
              <a:ext uri="{FF2B5EF4-FFF2-40B4-BE49-F238E27FC236}">
                <a16:creationId xmlns:a16="http://schemas.microsoft.com/office/drawing/2014/main" xmlns="" id="{E663B068-8F0B-544C-BD27-AD410916B319}"/>
              </a:ext>
            </a:extLst>
          </p:cNvPr>
          <p:cNvSpPr/>
          <p:nvPr/>
        </p:nvSpPr>
        <p:spPr>
          <a:xfrm rot="16200000">
            <a:off x="7571705" y="5866127"/>
            <a:ext cx="70148" cy="102174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8917" name="Picture 5">
            <a:extLst>
              <a:ext uri="{FF2B5EF4-FFF2-40B4-BE49-F238E27FC236}">
                <a16:creationId xmlns:a16="http://schemas.microsoft.com/office/drawing/2014/main" xmlns="" id="{8F325615-F99B-6BA8-AFC8-482BD46F55B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05" r="35561"/>
          <a:stretch/>
        </p:blipFill>
        <p:spPr bwMode="auto">
          <a:xfrm>
            <a:off x="2708043" y="2269713"/>
            <a:ext cx="4759089" cy="32615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xmlns="" id="{C66997D2-DCE7-36E0-5CCD-C70043BDBE7E}"/>
              </a:ext>
            </a:extLst>
          </p:cNvPr>
          <p:cNvCxnSpPr>
            <a:cxnSpLocks/>
          </p:cNvCxnSpPr>
          <p:nvPr/>
        </p:nvCxnSpPr>
        <p:spPr>
          <a:xfrm>
            <a:off x="3366683" y="2207070"/>
            <a:ext cx="221381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xmlns="" id="{BA325F8E-82EE-6B63-D0AB-57BD4FFABF71}"/>
              </a:ext>
            </a:extLst>
          </p:cNvPr>
          <p:cNvCxnSpPr>
            <a:cxnSpLocks/>
          </p:cNvCxnSpPr>
          <p:nvPr/>
        </p:nvCxnSpPr>
        <p:spPr>
          <a:xfrm>
            <a:off x="5734913" y="2207070"/>
            <a:ext cx="171706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C2588EED-C1CE-4456-3B88-6963FD5CED3D}"/>
              </a:ext>
            </a:extLst>
          </p:cNvPr>
          <p:cNvSpPr txBox="1"/>
          <p:nvPr/>
        </p:nvSpPr>
        <p:spPr>
          <a:xfrm>
            <a:off x="4322507" y="1770770"/>
            <a:ext cx="30556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i="1" dirty="0"/>
              <a:t>WT                   Adar D1113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E36A5318-06D4-C65C-9A87-F58CF72C107E}"/>
              </a:ext>
            </a:extLst>
          </p:cNvPr>
          <p:cNvSpPr txBox="1"/>
          <p:nvPr/>
        </p:nvSpPr>
        <p:spPr>
          <a:xfrm>
            <a:off x="2482368" y="1961082"/>
            <a:ext cx="4748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K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4B895405-2D6B-3EA4-019B-DE59D4B2A4B2}"/>
              </a:ext>
            </a:extLst>
          </p:cNvPr>
          <p:cNvSpPr txBox="1"/>
          <p:nvPr/>
        </p:nvSpPr>
        <p:spPr>
          <a:xfrm>
            <a:off x="2357801" y="2829174"/>
            <a:ext cx="574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15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F6A84992-C8AC-5EEE-3658-28794426AABA}"/>
              </a:ext>
            </a:extLst>
          </p:cNvPr>
          <p:cNvSpPr txBox="1"/>
          <p:nvPr/>
        </p:nvSpPr>
        <p:spPr>
          <a:xfrm>
            <a:off x="2357801" y="3270145"/>
            <a:ext cx="574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10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594B98D9-A8BE-40E0-6EE9-B980DCA82D57}"/>
              </a:ext>
            </a:extLst>
          </p:cNvPr>
          <p:cNvSpPr txBox="1"/>
          <p:nvPr/>
        </p:nvSpPr>
        <p:spPr>
          <a:xfrm>
            <a:off x="2482368" y="3578776"/>
            <a:ext cx="4443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7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F912351C-67B6-98A9-41EF-BAC2907ED129}"/>
              </a:ext>
            </a:extLst>
          </p:cNvPr>
          <p:cNvSpPr txBox="1"/>
          <p:nvPr/>
        </p:nvSpPr>
        <p:spPr>
          <a:xfrm>
            <a:off x="2483979" y="4400680"/>
            <a:ext cx="444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5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2740F6D8-371A-8821-AC28-9E989BF8209F}"/>
              </a:ext>
            </a:extLst>
          </p:cNvPr>
          <p:cNvSpPr txBox="1"/>
          <p:nvPr/>
        </p:nvSpPr>
        <p:spPr>
          <a:xfrm>
            <a:off x="2498047" y="5442031"/>
            <a:ext cx="444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5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C6B872B2-4183-4F0B-4063-223E2D2B4CAF}"/>
              </a:ext>
            </a:extLst>
          </p:cNvPr>
          <p:cNvSpPr txBox="1"/>
          <p:nvPr/>
        </p:nvSpPr>
        <p:spPr>
          <a:xfrm>
            <a:off x="2364023" y="2455463"/>
            <a:ext cx="574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250</a:t>
            </a:r>
          </a:p>
        </p:txBody>
      </p:sp>
      <p:pic>
        <p:nvPicPr>
          <p:cNvPr id="38920" name="Picture 8">
            <a:extLst>
              <a:ext uri="{FF2B5EF4-FFF2-40B4-BE49-F238E27FC236}">
                <a16:creationId xmlns:a16="http://schemas.microsoft.com/office/drawing/2014/main" xmlns="" id="{8655FC27-575E-649D-2C41-A504E193AC2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37" t="76922" r="27326"/>
          <a:stretch/>
        </p:blipFill>
        <p:spPr bwMode="auto">
          <a:xfrm>
            <a:off x="2894557" y="5531216"/>
            <a:ext cx="4571702" cy="10524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8E6FB7CB-DBE5-6593-3262-97B0E3735064}"/>
              </a:ext>
            </a:extLst>
          </p:cNvPr>
          <p:cNvSpPr txBox="1"/>
          <p:nvPr/>
        </p:nvSpPr>
        <p:spPr>
          <a:xfrm>
            <a:off x="2507547" y="5022529"/>
            <a:ext cx="444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7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BF1FFFBC-58C5-A476-FDAD-9D9CAA89AE93}"/>
              </a:ext>
            </a:extLst>
          </p:cNvPr>
          <p:cNvSpPr txBox="1"/>
          <p:nvPr/>
        </p:nvSpPr>
        <p:spPr>
          <a:xfrm>
            <a:off x="2499769" y="6105664"/>
            <a:ext cx="444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7</a:t>
            </a:r>
          </a:p>
        </p:txBody>
      </p:sp>
    </p:spTree>
    <p:extLst>
      <p:ext uri="{BB962C8B-B14F-4D97-AF65-F5344CB8AC3E}">
        <p14:creationId xmlns:p14="http://schemas.microsoft.com/office/powerpoint/2010/main" val="1625895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24F30EE7-4112-41D5-B011-DB39D4329643}"/>
              </a:ext>
            </a:extLst>
          </p:cNvPr>
          <p:cNvGrpSpPr/>
          <p:nvPr/>
        </p:nvGrpSpPr>
        <p:grpSpPr>
          <a:xfrm>
            <a:off x="1358364" y="1810724"/>
            <a:ext cx="9270531" cy="4843883"/>
            <a:chOff x="907603" y="737786"/>
            <a:chExt cx="9270531" cy="484388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6741C3CE-52F7-40F4-9C5A-C1CD5D01DB5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17642" y="738095"/>
              <a:ext cx="3062663" cy="2402089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1389B0E5-E516-446E-9FBF-008E1337383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4020585" y="737786"/>
              <a:ext cx="3063058" cy="2402398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DF59D040-2C68-4FD5-8C74-D6B1D439BA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15471" y="738095"/>
              <a:ext cx="3062663" cy="2402089"/>
            </a:xfrm>
            <a:prstGeom prst="rect">
              <a:avLst/>
            </a:prstGeom>
          </p:spPr>
        </p:pic>
        <p:pic>
          <p:nvPicPr>
            <p:cNvPr id="5" name="Picture 4" descr="A picture containing pink, purple&#10;&#10;Description automatically generated">
              <a:extLst>
                <a:ext uri="{FF2B5EF4-FFF2-40B4-BE49-F238E27FC236}">
                  <a16:creationId xmlns:a16="http://schemas.microsoft.com/office/drawing/2014/main" xmlns="" id="{918E890D-E232-424B-A51C-4653178D60D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7603" y="3171707"/>
              <a:ext cx="3072702" cy="2409962"/>
            </a:xfrm>
            <a:prstGeom prst="rect">
              <a:avLst/>
            </a:prstGeom>
          </p:spPr>
        </p:pic>
        <p:pic>
          <p:nvPicPr>
            <p:cNvPr id="6" name="Picture 5" descr="A picture containing indoor&#10;&#10;Description automatically generated">
              <a:extLst>
                <a:ext uri="{FF2B5EF4-FFF2-40B4-BE49-F238E27FC236}">
                  <a16:creationId xmlns:a16="http://schemas.microsoft.com/office/drawing/2014/main" xmlns="" id="{7441F9DE-F623-4D7C-B785-37C54B6B59F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7115470" y="3171707"/>
              <a:ext cx="3062664" cy="2402089"/>
            </a:xfrm>
            <a:prstGeom prst="rect">
              <a:avLst/>
            </a:prstGeom>
          </p:spPr>
        </p:pic>
        <p:pic>
          <p:nvPicPr>
            <p:cNvPr id="7" name="607FF14C-AA59-47F4-9FB0-E68859F407A7">
              <a:extLst>
                <a:ext uri="{FF2B5EF4-FFF2-40B4-BE49-F238E27FC236}">
                  <a16:creationId xmlns:a16="http://schemas.microsoft.com/office/drawing/2014/main" xmlns="" id="{AF3FF05D-8A8C-49E6-864B-F8112A40F38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20783" y="3171708"/>
              <a:ext cx="3062662" cy="2402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DC40180E-06CA-4B83-940E-BC7AE8F8C912}"/>
              </a:ext>
            </a:extLst>
          </p:cNvPr>
          <p:cNvSpPr txBox="1"/>
          <p:nvPr/>
        </p:nvSpPr>
        <p:spPr>
          <a:xfrm>
            <a:off x="972624" y="752298"/>
            <a:ext cx="10107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/>
              <a:t>Cortex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5FA3E1E-BB9F-4E00-9967-043C338C652C}"/>
              </a:ext>
            </a:extLst>
          </p:cNvPr>
          <p:cNvSpPr txBox="1"/>
          <p:nvPr/>
        </p:nvSpPr>
        <p:spPr>
          <a:xfrm>
            <a:off x="154547" y="128789"/>
            <a:ext cx="76519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Figure S3. ISG expression in eight months old mice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xmlns="" id="{035915C1-01BC-4939-AAA0-228631A7B2E0}"/>
              </a:ext>
            </a:extLst>
          </p:cNvPr>
          <p:cNvGrpSpPr/>
          <p:nvPr/>
        </p:nvGrpSpPr>
        <p:grpSpPr>
          <a:xfrm>
            <a:off x="712622" y="1301180"/>
            <a:ext cx="9008960" cy="5124447"/>
            <a:chOff x="712622" y="1301180"/>
            <a:chExt cx="9008960" cy="5124447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0FD61990-D59F-4F93-9B32-4E68B464057B}"/>
                </a:ext>
              </a:extLst>
            </p:cNvPr>
            <p:cNvSpPr txBox="1"/>
            <p:nvPr/>
          </p:nvSpPr>
          <p:spPr>
            <a:xfrm>
              <a:off x="2583084" y="1301182"/>
              <a:ext cx="5556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/>
                <a:t>H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42A60BA6-A6F0-46AC-8E66-173D13CD74B0}"/>
                </a:ext>
              </a:extLst>
            </p:cNvPr>
            <p:cNvSpPr txBox="1"/>
            <p:nvPr/>
          </p:nvSpPr>
          <p:spPr>
            <a:xfrm rot="16200000">
              <a:off x="635518" y="2827294"/>
              <a:ext cx="6158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/>
                <a:t>WT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300714DB-9B4D-4466-8202-6B8ABB79391D}"/>
                </a:ext>
              </a:extLst>
            </p:cNvPr>
            <p:cNvSpPr txBox="1"/>
            <p:nvPr/>
          </p:nvSpPr>
          <p:spPr>
            <a:xfrm rot="16200000">
              <a:off x="7669" y="5256877"/>
              <a:ext cx="187583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/>
                <a:t>Adar D1113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5112E138-021A-4D9E-8504-FA5CE0C689E0}"/>
                </a:ext>
              </a:extLst>
            </p:cNvPr>
            <p:cNvSpPr txBox="1"/>
            <p:nvPr/>
          </p:nvSpPr>
          <p:spPr>
            <a:xfrm>
              <a:off x="5392295" y="1301181"/>
              <a:ext cx="12211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/>
                <a:t>CXCL1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6865F578-EDD6-4AEA-8939-70E3C64490AD}"/>
                </a:ext>
              </a:extLst>
            </p:cNvPr>
            <p:cNvSpPr txBox="1"/>
            <p:nvPr/>
          </p:nvSpPr>
          <p:spPr>
            <a:xfrm>
              <a:off x="8672548" y="1301180"/>
              <a:ext cx="10490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/>
                <a:t>ISG-15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83A1F9CE-C296-E41A-A99F-472605EFAEA6}"/>
              </a:ext>
            </a:extLst>
          </p:cNvPr>
          <p:cNvSpPr txBox="1"/>
          <p:nvPr/>
        </p:nvSpPr>
        <p:spPr>
          <a:xfrm>
            <a:off x="2864717" y="2204282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97FC9651-752C-DF47-B722-2A833808FF62}"/>
              </a:ext>
            </a:extLst>
          </p:cNvPr>
          <p:cNvSpPr txBox="1"/>
          <p:nvPr/>
        </p:nvSpPr>
        <p:spPr>
          <a:xfrm>
            <a:off x="6175006" y="2161741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A39BCD6B-974F-1C1A-6DCF-3105A7940954}"/>
              </a:ext>
            </a:extLst>
          </p:cNvPr>
          <p:cNvSpPr txBox="1"/>
          <p:nvPr/>
        </p:nvSpPr>
        <p:spPr>
          <a:xfrm>
            <a:off x="9185852" y="2216314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95498046-0E48-3DE2-BD09-5D94B7B9A355}"/>
              </a:ext>
            </a:extLst>
          </p:cNvPr>
          <p:cNvSpPr txBox="1"/>
          <p:nvPr/>
        </p:nvSpPr>
        <p:spPr>
          <a:xfrm>
            <a:off x="2559398" y="4533803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E43EF62F-5867-E55D-1B79-8EF8BC3457FE}"/>
              </a:ext>
            </a:extLst>
          </p:cNvPr>
          <p:cNvSpPr txBox="1"/>
          <p:nvPr/>
        </p:nvSpPr>
        <p:spPr>
          <a:xfrm>
            <a:off x="5869687" y="4491262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24A2E17A-44AB-32B1-C989-C32151DE6F3A}"/>
              </a:ext>
            </a:extLst>
          </p:cNvPr>
          <p:cNvSpPr txBox="1"/>
          <p:nvPr/>
        </p:nvSpPr>
        <p:spPr>
          <a:xfrm>
            <a:off x="9179977" y="4482011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</p:spTree>
    <p:extLst>
      <p:ext uri="{BB962C8B-B14F-4D97-AF65-F5344CB8AC3E}">
        <p14:creationId xmlns:p14="http://schemas.microsoft.com/office/powerpoint/2010/main" val="31908922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33AADFD8-2001-4931-BE97-14D3552B3C48}"/>
              </a:ext>
            </a:extLst>
          </p:cNvPr>
          <p:cNvSpPr txBox="1"/>
          <p:nvPr/>
        </p:nvSpPr>
        <p:spPr>
          <a:xfrm>
            <a:off x="972624" y="752298"/>
            <a:ext cx="10107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/>
              <a:t>DGM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9EE1B0F2-6A25-4653-93D8-0FCE7937447B}"/>
              </a:ext>
            </a:extLst>
          </p:cNvPr>
          <p:cNvGrpSpPr/>
          <p:nvPr/>
        </p:nvGrpSpPr>
        <p:grpSpPr>
          <a:xfrm>
            <a:off x="1327204" y="1789644"/>
            <a:ext cx="9316608" cy="4867433"/>
            <a:chOff x="1082506" y="1019037"/>
            <a:chExt cx="9316608" cy="486743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8B173360-6330-4ECF-B2FE-10BC7FB9CEE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2506" y="1019037"/>
              <a:ext cx="3072704" cy="2409964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A43E5A11-B5C6-4571-AF05-238BFFE4E75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4204461" y="1019037"/>
              <a:ext cx="3072703" cy="2409963"/>
            </a:xfrm>
            <a:prstGeom prst="rect">
              <a:avLst/>
            </a:prstGeom>
          </p:spPr>
        </p:pic>
        <p:pic>
          <p:nvPicPr>
            <p:cNvPr id="5" name="Picture 4" descr="A picture containing snow, slope&#10;&#10;Description automatically generated">
              <a:extLst>
                <a:ext uri="{FF2B5EF4-FFF2-40B4-BE49-F238E27FC236}">
                  <a16:creationId xmlns:a16="http://schemas.microsoft.com/office/drawing/2014/main" xmlns="" id="{234AB23E-1C9A-4835-BE8A-A7742A2B0C4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7326411" y="1042382"/>
              <a:ext cx="3072703" cy="2409963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E46583ED-F327-496A-93EB-E7013B6BAD0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1082509" y="3476509"/>
              <a:ext cx="3072701" cy="2409961"/>
            </a:xfrm>
            <a:prstGeom prst="rect">
              <a:avLst/>
            </a:prstGeom>
          </p:spPr>
        </p:pic>
        <p:pic>
          <p:nvPicPr>
            <p:cNvPr id="7" name="Picture 6" descr="Map&#10;&#10;Description automatically generated with low confidence">
              <a:extLst>
                <a:ext uri="{FF2B5EF4-FFF2-40B4-BE49-F238E27FC236}">
                  <a16:creationId xmlns:a16="http://schemas.microsoft.com/office/drawing/2014/main" xmlns="" id="{B9EB1B4D-55A5-45C3-8F68-0CF9413DD7B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4204462" y="3476509"/>
              <a:ext cx="3072700" cy="2409961"/>
            </a:xfrm>
            <a:prstGeom prst="rect">
              <a:avLst/>
            </a:prstGeom>
          </p:spPr>
        </p:pic>
        <p:pic>
          <p:nvPicPr>
            <p:cNvPr id="8" name="Picture 7" descr="Background pattern&#10;&#10;Description automatically generated">
              <a:extLst>
                <a:ext uri="{FF2B5EF4-FFF2-40B4-BE49-F238E27FC236}">
                  <a16:creationId xmlns:a16="http://schemas.microsoft.com/office/drawing/2014/main" xmlns="" id="{C0E5945D-0E17-44AD-AC89-9AF11A3D126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7326414" y="3476509"/>
              <a:ext cx="3072700" cy="2409961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273D4B7C-7E70-408A-A9FD-A47EAF8DB6BE}"/>
              </a:ext>
            </a:extLst>
          </p:cNvPr>
          <p:cNvSpPr txBox="1"/>
          <p:nvPr/>
        </p:nvSpPr>
        <p:spPr>
          <a:xfrm>
            <a:off x="154547" y="128789"/>
            <a:ext cx="76519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Figure S4. ISG expression in eight months old mice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4571177A-D9D0-4C4B-87FB-5FE1B6184EF7}"/>
              </a:ext>
            </a:extLst>
          </p:cNvPr>
          <p:cNvGrpSpPr/>
          <p:nvPr/>
        </p:nvGrpSpPr>
        <p:grpSpPr>
          <a:xfrm>
            <a:off x="712622" y="1301181"/>
            <a:ext cx="8919355" cy="5124446"/>
            <a:chOff x="712622" y="1301181"/>
            <a:chExt cx="8919355" cy="5124446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4CB95E8D-AA19-42DB-9186-4E7866D7ACB6}"/>
                </a:ext>
              </a:extLst>
            </p:cNvPr>
            <p:cNvSpPr txBox="1"/>
            <p:nvPr/>
          </p:nvSpPr>
          <p:spPr>
            <a:xfrm>
              <a:off x="2583084" y="1301182"/>
              <a:ext cx="5556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/>
                <a:t>HE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07C3C827-FD3D-4983-9FF4-D171025FE9ED}"/>
                </a:ext>
              </a:extLst>
            </p:cNvPr>
            <p:cNvSpPr txBox="1"/>
            <p:nvPr/>
          </p:nvSpPr>
          <p:spPr>
            <a:xfrm rot="16200000">
              <a:off x="635518" y="2827294"/>
              <a:ext cx="6158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/>
                <a:t>W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B41E27DD-580E-46C9-8961-2128664EEEB5}"/>
                </a:ext>
              </a:extLst>
            </p:cNvPr>
            <p:cNvSpPr txBox="1"/>
            <p:nvPr/>
          </p:nvSpPr>
          <p:spPr>
            <a:xfrm rot="16200000">
              <a:off x="7669" y="5256877"/>
              <a:ext cx="187583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/>
                <a:t>Adar D1113H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33FBF7B8-A1E0-4BE4-BDA4-9945BC2585D4}"/>
                </a:ext>
              </a:extLst>
            </p:cNvPr>
            <p:cNvSpPr txBox="1"/>
            <p:nvPr/>
          </p:nvSpPr>
          <p:spPr>
            <a:xfrm>
              <a:off x="5374930" y="1301181"/>
              <a:ext cx="12211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/>
                <a:t>CXCL1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2471F774-4CC1-4204-A76B-12BFFC8F3166}"/>
                </a:ext>
              </a:extLst>
            </p:cNvPr>
            <p:cNvSpPr txBox="1"/>
            <p:nvPr/>
          </p:nvSpPr>
          <p:spPr>
            <a:xfrm>
              <a:off x="8582943" y="1304669"/>
              <a:ext cx="10490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/>
                <a:t>ISG-15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1635B920-F335-490B-8CDE-AE3867707E3D}"/>
              </a:ext>
            </a:extLst>
          </p:cNvPr>
          <p:cNvSpPr txBox="1"/>
          <p:nvPr/>
        </p:nvSpPr>
        <p:spPr>
          <a:xfrm>
            <a:off x="4742515" y="4893428"/>
            <a:ext cx="55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C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C44732D5-3AB6-4BB7-8A54-4AA10F4E8EA5}"/>
              </a:ext>
            </a:extLst>
          </p:cNvPr>
          <p:cNvSpPr txBox="1"/>
          <p:nvPr/>
        </p:nvSpPr>
        <p:spPr>
          <a:xfrm>
            <a:off x="7582113" y="4343002"/>
            <a:ext cx="55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C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003C65E9-018D-4717-96A3-B454DA2B58D4}"/>
              </a:ext>
            </a:extLst>
          </p:cNvPr>
          <p:cNvSpPr txBox="1"/>
          <p:nvPr/>
        </p:nvSpPr>
        <p:spPr>
          <a:xfrm>
            <a:off x="1389926" y="4521058"/>
            <a:ext cx="55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C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2C6517E3-E8D2-47B0-BE54-5FF33D81A1B2}"/>
              </a:ext>
            </a:extLst>
          </p:cNvPr>
          <p:cNvSpPr txBox="1"/>
          <p:nvPr/>
        </p:nvSpPr>
        <p:spPr>
          <a:xfrm>
            <a:off x="2237039" y="4409529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3E2D6710-4652-48D5-9AEE-450E1C10E3CE}"/>
              </a:ext>
            </a:extLst>
          </p:cNvPr>
          <p:cNvSpPr txBox="1"/>
          <p:nvPr/>
        </p:nvSpPr>
        <p:spPr>
          <a:xfrm>
            <a:off x="5565833" y="4322410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D0319FD0-ADEC-4825-85D5-5268763395F5}"/>
              </a:ext>
            </a:extLst>
          </p:cNvPr>
          <p:cNvSpPr txBox="1"/>
          <p:nvPr/>
        </p:nvSpPr>
        <p:spPr>
          <a:xfrm>
            <a:off x="8082546" y="4689956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2EF7C0A4-F3E3-4CB6-9C61-B9F2A6667450}"/>
              </a:ext>
            </a:extLst>
          </p:cNvPr>
          <p:cNvSpPr txBox="1"/>
          <p:nvPr/>
        </p:nvSpPr>
        <p:spPr>
          <a:xfrm>
            <a:off x="6712961" y="1729400"/>
            <a:ext cx="55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CP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AF78A8C8-584A-4E32-8F19-55E599D09A81}"/>
              </a:ext>
            </a:extLst>
          </p:cNvPr>
          <p:cNvSpPr txBox="1"/>
          <p:nvPr/>
        </p:nvSpPr>
        <p:spPr>
          <a:xfrm>
            <a:off x="9470136" y="1720046"/>
            <a:ext cx="55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C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A2C2DED1-E1FE-4904-A812-633426D34F71}"/>
              </a:ext>
            </a:extLst>
          </p:cNvPr>
          <p:cNvSpPr txBox="1"/>
          <p:nvPr/>
        </p:nvSpPr>
        <p:spPr>
          <a:xfrm>
            <a:off x="1657561" y="1901140"/>
            <a:ext cx="55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CP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C2FE034B-CB8D-4BBB-9A79-68FB5AB06EA7}"/>
              </a:ext>
            </a:extLst>
          </p:cNvPr>
          <p:cNvSpPr txBox="1"/>
          <p:nvPr/>
        </p:nvSpPr>
        <p:spPr>
          <a:xfrm>
            <a:off x="1481384" y="1789644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B028777A-46A5-4410-BBF7-C33C1373DFBF}"/>
              </a:ext>
            </a:extLst>
          </p:cNvPr>
          <p:cNvSpPr txBox="1"/>
          <p:nvPr/>
        </p:nvSpPr>
        <p:spPr>
          <a:xfrm>
            <a:off x="5406030" y="1718260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14014CE6-138D-4873-BCBA-9177BC929685}"/>
              </a:ext>
            </a:extLst>
          </p:cNvPr>
          <p:cNvSpPr txBox="1"/>
          <p:nvPr/>
        </p:nvSpPr>
        <p:spPr>
          <a:xfrm>
            <a:off x="8410787" y="1720046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</p:spTree>
    <p:extLst>
      <p:ext uri="{BB962C8B-B14F-4D97-AF65-F5344CB8AC3E}">
        <p14:creationId xmlns:p14="http://schemas.microsoft.com/office/powerpoint/2010/main" val="2555084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D76289BD-DA45-4157-99FB-35A54E01B16F}"/>
              </a:ext>
            </a:extLst>
          </p:cNvPr>
          <p:cNvGrpSpPr/>
          <p:nvPr/>
        </p:nvGrpSpPr>
        <p:grpSpPr>
          <a:xfrm>
            <a:off x="2021701" y="919117"/>
            <a:ext cx="7215871" cy="5826675"/>
            <a:chOff x="2021701" y="700174"/>
            <a:chExt cx="7215871" cy="5826675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CBC90BB1-1E4E-4B55-8676-4EF704D65CBC}"/>
                </a:ext>
              </a:extLst>
            </p:cNvPr>
            <p:cNvSpPr txBox="1"/>
            <p:nvPr/>
          </p:nvSpPr>
          <p:spPr>
            <a:xfrm>
              <a:off x="3672372" y="737906"/>
              <a:ext cx="77797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/>
                <a:t>IBA1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xmlns="" id="{6E94CF4D-9E93-453B-A63C-655EC7BB9002}"/>
                </a:ext>
              </a:extLst>
            </p:cNvPr>
            <p:cNvSpPr txBox="1"/>
            <p:nvPr/>
          </p:nvSpPr>
          <p:spPr>
            <a:xfrm rot="16200000">
              <a:off x="1944597" y="2561431"/>
              <a:ext cx="6158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/>
                <a:t>WT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E53929C1-B7F1-4FEF-ADBE-9B0EB8DB8049}"/>
                </a:ext>
              </a:extLst>
            </p:cNvPr>
            <p:cNvSpPr txBox="1"/>
            <p:nvPr/>
          </p:nvSpPr>
          <p:spPr>
            <a:xfrm>
              <a:off x="7136824" y="700174"/>
              <a:ext cx="8533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/>
                <a:t>GFAP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CFA30027-0BA5-40D0-A777-89AEF78979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5971856" y="1343873"/>
              <a:ext cx="3265715" cy="256134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7F6686BA-009B-458C-AF3E-FE1577EA0A5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623397" y="1343873"/>
              <a:ext cx="3245832" cy="254575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7DB91FE8-EC30-4389-B39B-39CF0A63F8B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2623397" y="3965503"/>
              <a:ext cx="3245832" cy="254575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0F8502B7-10C6-4CCA-A161-60C8455B91C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5971856" y="3965503"/>
              <a:ext cx="3265716" cy="2561346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E9FBDBC8-D4F7-43E9-89CA-F3298BA9309F}"/>
              </a:ext>
            </a:extLst>
          </p:cNvPr>
          <p:cNvSpPr txBox="1"/>
          <p:nvPr/>
        </p:nvSpPr>
        <p:spPr>
          <a:xfrm>
            <a:off x="692555" y="820392"/>
            <a:ext cx="26832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Eight weeks, Cortex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D56672CE-4027-4AB6-8F76-348A8441DF96}"/>
              </a:ext>
            </a:extLst>
          </p:cNvPr>
          <p:cNvSpPr txBox="1"/>
          <p:nvPr/>
        </p:nvSpPr>
        <p:spPr>
          <a:xfrm>
            <a:off x="154547" y="128789"/>
            <a:ext cx="121552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Figure S5. IBA1 and GFAP staining in </a:t>
            </a:r>
            <a:r>
              <a:rPr lang="en-US" sz="2800" b="1" i="1" dirty="0"/>
              <a:t>Adar</a:t>
            </a:r>
            <a:r>
              <a:rPr lang="en-US" sz="2800" b="1" i="1" baseline="30000" dirty="0"/>
              <a:t>D1113H /D1113H</a:t>
            </a:r>
            <a:r>
              <a:rPr lang="en-US" sz="2800" b="1" i="1" dirty="0"/>
              <a:t>;ifih1</a:t>
            </a:r>
            <a:r>
              <a:rPr lang="en-US" sz="2800" b="1" i="1" baseline="30000" dirty="0"/>
              <a:t>-/- </a:t>
            </a:r>
            <a:r>
              <a:rPr lang="en-US" sz="2800" b="1" dirty="0"/>
              <a:t>double mutant mi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AB3BE06-FF2B-4D4A-84F1-3F67152C24CA}"/>
              </a:ext>
            </a:extLst>
          </p:cNvPr>
          <p:cNvSpPr txBox="1"/>
          <p:nvPr/>
        </p:nvSpPr>
        <p:spPr>
          <a:xfrm>
            <a:off x="692555" y="1418514"/>
            <a:ext cx="801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48315F9-9496-4F98-AE34-F439119C5E2C}"/>
              </a:ext>
            </a:extLst>
          </p:cNvPr>
          <p:cNvSpPr txBox="1"/>
          <p:nvPr/>
        </p:nvSpPr>
        <p:spPr>
          <a:xfrm rot="16200000">
            <a:off x="1038348" y="5006921"/>
            <a:ext cx="23391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i="1" dirty="0"/>
              <a:t>Adar</a:t>
            </a:r>
            <a:r>
              <a:rPr lang="en-US" sz="2400" b="1" i="1" baseline="30000" dirty="0"/>
              <a:t>D1113H /D1113H </a:t>
            </a:r>
            <a:endParaRPr lang="en-US" sz="2400" b="1" dirty="0"/>
          </a:p>
          <a:p>
            <a:pPr algn="ctr"/>
            <a:r>
              <a:rPr lang="en-US" sz="2400" b="1" dirty="0"/>
              <a:t>ifih1</a:t>
            </a:r>
            <a:r>
              <a:rPr lang="en-US" sz="2400" b="1" baseline="30000" dirty="0"/>
              <a:t>-/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1FFB6B0E-71E5-1BC0-39EB-C3298E986B23}"/>
              </a:ext>
            </a:extLst>
          </p:cNvPr>
          <p:cNvSpPr txBox="1"/>
          <p:nvPr/>
        </p:nvSpPr>
        <p:spPr>
          <a:xfrm>
            <a:off x="3672372" y="2297842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777373AE-1B5D-F26C-D44A-9BED3531CE45}"/>
              </a:ext>
            </a:extLst>
          </p:cNvPr>
          <p:cNvSpPr txBox="1"/>
          <p:nvPr/>
        </p:nvSpPr>
        <p:spPr>
          <a:xfrm>
            <a:off x="6982661" y="2255301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E18DC729-AFBF-87D6-5131-F6AA5FD47664}"/>
              </a:ext>
            </a:extLst>
          </p:cNvPr>
          <p:cNvSpPr txBox="1"/>
          <p:nvPr/>
        </p:nvSpPr>
        <p:spPr>
          <a:xfrm>
            <a:off x="3672372" y="4732471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4294ABDB-B6CA-A692-B54C-37F7AC9B98BB}"/>
              </a:ext>
            </a:extLst>
          </p:cNvPr>
          <p:cNvSpPr txBox="1"/>
          <p:nvPr/>
        </p:nvSpPr>
        <p:spPr>
          <a:xfrm>
            <a:off x="6982661" y="4689930"/>
            <a:ext cx="548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TX</a:t>
            </a:r>
          </a:p>
        </p:txBody>
      </p:sp>
    </p:spTree>
    <p:extLst>
      <p:ext uri="{BB962C8B-B14F-4D97-AF65-F5344CB8AC3E}">
        <p14:creationId xmlns:p14="http://schemas.microsoft.com/office/powerpoint/2010/main" val="14653992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xmlns="" id="{DB3EF7C1-2A94-44B1-9EB6-424FEDD069F6}"/>
              </a:ext>
            </a:extLst>
          </p:cNvPr>
          <p:cNvGrpSpPr/>
          <p:nvPr/>
        </p:nvGrpSpPr>
        <p:grpSpPr>
          <a:xfrm>
            <a:off x="2213463" y="971038"/>
            <a:ext cx="7238404" cy="5736116"/>
            <a:chOff x="2213463" y="661942"/>
            <a:chExt cx="7238404" cy="573611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1F3B3F01-8B58-4260-9A7A-3E7D290D07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828627" y="1199489"/>
              <a:ext cx="3265715" cy="256134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E3296CFF-1B82-4EE8-AEE0-5D89FBCD5C9F}"/>
                </a:ext>
              </a:extLst>
            </p:cNvPr>
            <p:cNvSpPr txBox="1"/>
            <p:nvPr/>
          </p:nvSpPr>
          <p:spPr>
            <a:xfrm>
              <a:off x="4193322" y="661942"/>
              <a:ext cx="77797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/>
                <a:t>IBA1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73462C28-2737-41F0-A0DE-7866CB9B34D1}"/>
                </a:ext>
              </a:extLst>
            </p:cNvPr>
            <p:cNvSpPr txBox="1"/>
            <p:nvPr/>
          </p:nvSpPr>
          <p:spPr>
            <a:xfrm rot="16200000">
              <a:off x="2136359" y="2480160"/>
              <a:ext cx="6158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/>
                <a:t>WT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1022341C-41F5-495E-9AEB-4DC6AA7DB52A}"/>
                </a:ext>
              </a:extLst>
            </p:cNvPr>
            <p:cNvSpPr txBox="1"/>
            <p:nvPr/>
          </p:nvSpPr>
          <p:spPr>
            <a:xfrm>
              <a:off x="7261261" y="661942"/>
              <a:ext cx="8533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/>
                <a:t>GFAP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F2A9F8EC-87FD-48EC-8D00-F9D187851D0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6186152" y="1199487"/>
              <a:ext cx="3265715" cy="256134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C6C0D1F9-FDA7-4467-AB00-31E1ADB03E8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828626" y="3836713"/>
              <a:ext cx="3265715" cy="2561345"/>
            </a:xfrm>
            <a:prstGeom prst="rect">
              <a:avLst/>
            </a:prstGeom>
          </p:spPr>
        </p:pic>
        <p:pic>
          <p:nvPicPr>
            <p:cNvPr id="10" name="241FD3C8-42E9-4B90-9E53-378F201BAD59">
              <a:extLst>
                <a:ext uri="{FF2B5EF4-FFF2-40B4-BE49-F238E27FC236}">
                  <a16:creationId xmlns:a16="http://schemas.microsoft.com/office/drawing/2014/main" xmlns="" id="{7CE7DC8E-6BD5-4E80-ADAE-CF2FF1B71FF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86152" y="3836712"/>
              <a:ext cx="3265714" cy="25613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E3005195-F2F0-43AE-9DB4-FFD371996790}"/>
              </a:ext>
            </a:extLst>
          </p:cNvPr>
          <p:cNvSpPr txBox="1"/>
          <p:nvPr/>
        </p:nvSpPr>
        <p:spPr>
          <a:xfrm>
            <a:off x="822960" y="926532"/>
            <a:ext cx="25091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Eight weeks, DG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5158EF3-8FF8-4602-A449-940E7ACFADD3}"/>
              </a:ext>
            </a:extLst>
          </p:cNvPr>
          <p:cNvSpPr txBox="1"/>
          <p:nvPr/>
        </p:nvSpPr>
        <p:spPr>
          <a:xfrm>
            <a:off x="154547" y="128789"/>
            <a:ext cx="121552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Figure S5. IBA1 and GFAP staining in </a:t>
            </a:r>
            <a:r>
              <a:rPr lang="en-US" sz="2800" b="1" i="1" dirty="0"/>
              <a:t>Adar</a:t>
            </a:r>
            <a:r>
              <a:rPr lang="en-US" sz="2800" b="1" i="1" baseline="30000" dirty="0"/>
              <a:t>D1113H /D1113H</a:t>
            </a:r>
            <a:r>
              <a:rPr lang="en-US" sz="2800" b="1" i="1" dirty="0"/>
              <a:t>;ifih1</a:t>
            </a:r>
            <a:r>
              <a:rPr lang="en-US" sz="2800" b="1" i="1" baseline="30000" dirty="0"/>
              <a:t>-/- </a:t>
            </a:r>
            <a:r>
              <a:rPr lang="en-US" sz="2800" b="1" dirty="0"/>
              <a:t>double mutant mic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FA11E59E-93D0-434C-AD5D-611911983227}"/>
              </a:ext>
            </a:extLst>
          </p:cNvPr>
          <p:cNvSpPr txBox="1"/>
          <p:nvPr/>
        </p:nvSpPr>
        <p:spPr>
          <a:xfrm>
            <a:off x="634682" y="1388197"/>
            <a:ext cx="801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6E3169F4-0265-4436-844A-F9F3D2E55112}"/>
              </a:ext>
            </a:extLst>
          </p:cNvPr>
          <p:cNvSpPr txBox="1"/>
          <p:nvPr/>
        </p:nvSpPr>
        <p:spPr>
          <a:xfrm>
            <a:off x="5525965" y="2884677"/>
            <a:ext cx="55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C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BFEE9D69-0538-4954-9854-3A1B838D32E6}"/>
              </a:ext>
            </a:extLst>
          </p:cNvPr>
          <p:cNvSpPr txBox="1"/>
          <p:nvPr/>
        </p:nvSpPr>
        <p:spPr>
          <a:xfrm>
            <a:off x="8915396" y="3100331"/>
            <a:ext cx="55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C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C23FA3C0-EB52-4F16-8A44-A06AFF9FB768}"/>
              </a:ext>
            </a:extLst>
          </p:cNvPr>
          <p:cNvSpPr txBox="1"/>
          <p:nvPr/>
        </p:nvSpPr>
        <p:spPr>
          <a:xfrm>
            <a:off x="5525965" y="3555656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BB1B2B4A-5143-400A-9136-ACE40385D921}"/>
              </a:ext>
            </a:extLst>
          </p:cNvPr>
          <p:cNvSpPr txBox="1"/>
          <p:nvPr/>
        </p:nvSpPr>
        <p:spPr>
          <a:xfrm>
            <a:off x="8970499" y="3573003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166206E5-C593-4948-A838-9E95BA75F22B}"/>
              </a:ext>
            </a:extLst>
          </p:cNvPr>
          <p:cNvSpPr txBox="1"/>
          <p:nvPr/>
        </p:nvSpPr>
        <p:spPr>
          <a:xfrm>
            <a:off x="5838026" y="6140380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076054B0-EFED-449A-80BE-8FB23A827942}"/>
              </a:ext>
            </a:extLst>
          </p:cNvPr>
          <p:cNvSpPr txBox="1"/>
          <p:nvPr/>
        </p:nvSpPr>
        <p:spPr>
          <a:xfrm>
            <a:off x="9206320" y="6323260"/>
            <a:ext cx="209003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/>
              <a:t>V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E937B86F-0172-0984-1A4E-E661F0A61940}"/>
              </a:ext>
            </a:extLst>
          </p:cNvPr>
          <p:cNvSpPr txBox="1"/>
          <p:nvPr/>
        </p:nvSpPr>
        <p:spPr>
          <a:xfrm rot="16200000">
            <a:off x="1243577" y="5103970"/>
            <a:ext cx="23391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i="1" dirty="0"/>
              <a:t>Adar</a:t>
            </a:r>
            <a:r>
              <a:rPr lang="en-US" sz="2400" b="1" i="1" baseline="30000" dirty="0"/>
              <a:t>D1113H /D1113H </a:t>
            </a:r>
            <a:endParaRPr lang="en-US" sz="2400" b="1" dirty="0"/>
          </a:p>
          <a:p>
            <a:pPr algn="ctr"/>
            <a:r>
              <a:rPr lang="en-US" sz="2400" b="1" dirty="0"/>
              <a:t>ifih1</a:t>
            </a:r>
            <a:r>
              <a:rPr lang="en-US" sz="2400" b="1" baseline="30000" dirty="0"/>
              <a:t>-/-</a:t>
            </a:r>
          </a:p>
        </p:txBody>
      </p:sp>
    </p:spTree>
    <p:extLst>
      <p:ext uri="{BB962C8B-B14F-4D97-AF65-F5344CB8AC3E}">
        <p14:creationId xmlns:p14="http://schemas.microsoft.com/office/powerpoint/2010/main" val="3513838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77</TotalTime>
  <Words>168</Words>
  <Application>Microsoft Office PowerPoint</Application>
  <PresentationFormat>Widescreen</PresentationFormat>
  <Paragraphs>81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DengXian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Qingde</dc:creator>
  <cp:lastModifiedBy>Aarthi K.</cp:lastModifiedBy>
  <cp:revision>43</cp:revision>
  <cp:lastPrinted>2022-02-14T21:45:30Z</cp:lastPrinted>
  <dcterms:created xsi:type="dcterms:W3CDTF">2021-05-26T14:43:33Z</dcterms:created>
  <dcterms:modified xsi:type="dcterms:W3CDTF">2022-11-17T06:42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e4b1be8-281e-475d-98b0-21c3457e5a46_Enabled">
    <vt:lpwstr>true</vt:lpwstr>
  </property>
  <property fmtid="{D5CDD505-2E9C-101B-9397-08002B2CF9AE}" pid="3" name="MSIP_Label_5e4b1be8-281e-475d-98b0-21c3457e5a46_SetDate">
    <vt:lpwstr>2021-05-26T14:43:33Z</vt:lpwstr>
  </property>
  <property fmtid="{D5CDD505-2E9C-101B-9397-08002B2CF9AE}" pid="4" name="MSIP_Label_5e4b1be8-281e-475d-98b0-21c3457e5a46_Method">
    <vt:lpwstr>Standard</vt:lpwstr>
  </property>
  <property fmtid="{D5CDD505-2E9C-101B-9397-08002B2CF9AE}" pid="5" name="MSIP_Label_5e4b1be8-281e-475d-98b0-21c3457e5a46_Name">
    <vt:lpwstr>Public</vt:lpwstr>
  </property>
  <property fmtid="{D5CDD505-2E9C-101B-9397-08002B2CF9AE}" pid="6" name="MSIP_Label_5e4b1be8-281e-475d-98b0-21c3457e5a46_SiteId">
    <vt:lpwstr>8b3dd73e-4e72-4679-b191-56da1588712b</vt:lpwstr>
  </property>
  <property fmtid="{D5CDD505-2E9C-101B-9397-08002B2CF9AE}" pid="7" name="MSIP_Label_5e4b1be8-281e-475d-98b0-21c3457e5a46_ActionId">
    <vt:lpwstr>ee729b6a-e5aa-4616-9b56-4abbef1aee72</vt:lpwstr>
  </property>
  <property fmtid="{D5CDD505-2E9C-101B-9397-08002B2CF9AE}" pid="8" name="MSIP_Label_5e4b1be8-281e-475d-98b0-21c3457e5a46_ContentBits">
    <vt:lpwstr>0</vt:lpwstr>
  </property>
</Properties>
</file>